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110D1"/>
    <a:srgbClr val="010C9D"/>
    <a:srgbClr val="AED6F9"/>
    <a:srgbClr val="8C97EC"/>
    <a:srgbClr val="99B2DF"/>
    <a:srgbClr val="E49991"/>
    <a:srgbClr val="FFC9C2"/>
    <a:srgbClr val="7B0101"/>
    <a:srgbClr val="950101"/>
    <a:srgbClr val="FFA9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 varScale="1">
        <p:scale>
          <a:sx n="106" d="100"/>
          <a:sy n="106" d="100"/>
        </p:scale>
        <p:origin x="5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14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E806FAF-9D3E-49D9-BF3D-E9CCC82B41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it-IT" dirty="0"/>
          </a:p>
          <a:p>
            <a:endParaRPr lang="it-IT" dirty="0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1" y="720045"/>
            <a:ext cx="12192000" cy="4805131"/>
          </a:xfrm>
          <a:prstGeom prst="rect">
            <a:avLst/>
          </a:prstGeom>
          <a:solidFill>
            <a:srgbClr val="99B2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b="1" dirty="0"/>
              <a:t>Conclusion</a:t>
            </a:r>
            <a:endParaRPr lang="it-IT" dirty="0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57C6657B-C862-4624-AF23-0815F276EF35}"/>
              </a:ext>
            </a:extLst>
          </p:cNvPr>
          <p:cNvSpPr/>
          <p:nvPr/>
        </p:nvSpPr>
        <p:spPr>
          <a:xfrm>
            <a:off x="3921658" y="720045"/>
            <a:ext cx="4097073" cy="478211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48570" y="5788510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387819" y="720045"/>
            <a:ext cx="30276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b="1" dirty="0"/>
              <a:t>    METHOD</a:t>
            </a:r>
            <a:r>
              <a:rPr lang="it-IT" b="1" dirty="0"/>
              <a:t>	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89B844B-5329-4EF8-A25F-1F177F64B210}"/>
              </a:ext>
            </a:extLst>
          </p:cNvPr>
          <p:cNvSpPr txBox="1"/>
          <p:nvPr/>
        </p:nvSpPr>
        <p:spPr>
          <a:xfrm>
            <a:off x="4247348" y="697028"/>
            <a:ext cx="30581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b="1" dirty="0"/>
              <a:t>RESULTS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82"/>
          <a:stretch/>
        </p:blipFill>
        <p:spPr>
          <a:xfrm>
            <a:off x="0" y="5589917"/>
            <a:ext cx="2592354" cy="1268084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-693839" y="55552"/>
            <a:ext cx="12181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The Influence of </a:t>
            </a:r>
            <a:r>
              <a:rPr lang="en-GB" sz="1400" b="1" dirty="0" err="1"/>
              <a:t>Laparscopic</a:t>
            </a:r>
            <a:r>
              <a:rPr lang="en-GB" sz="1400" b="1" dirty="0"/>
              <a:t> Sleeve Gastrectomy on Male Erectile Function among Morbid Obese Patients: An Observational Study</a:t>
            </a:r>
            <a:endParaRPr lang="it-IT" sz="1400" b="1" dirty="0"/>
          </a:p>
        </p:txBody>
      </p:sp>
      <p:sp>
        <p:nvSpPr>
          <p:cNvPr id="127" name="Rectangle 126"/>
          <p:cNvSpPr/>
          <p:nvPr/>
        </p:nvSpPr>
        <p:spPr>
          <a:xfrm>
            <a:off x="9065876" y="690121"/>
            <a:ext cx="217517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2800" b="1" dirty="0"/>
              <a:t>CONCLUSIO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03F1B40-FED4-94F2-5A90-654A90DDD565}"/>
              </a:ext>
            </a:extLst>
          </p:cNvPr>
          <p:cNvSpPr/>
          <p:nvPr/>
        </p:nvSpPr>
        <p:spPr>
          <a:xfrm>
            <a:off x="2702935" y="5777553"/>
            <a:ext cx="5653413" cy="714487"/>
          </a:xfrm>
          <a:prstGeom prst="rect">
            <a:avLst/>
          </a:prstGeom>
          <a:noFill/>
          <a:ln w="28575">
            <a:solidFill>
              <a:srgbClr val="010C9D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7BA675-CE27-87DF-03FC-E1C2B287BDD8}"/>
              </a:ext>
            </a:extLst>
          </p:cNvPr>
          <p:cNvSpPr txBox="1"/>
          <p:nvPr/>
        </p:nvSpPr>
        <p:spPr>
          <a:xfrm>
            <a:off x="3823198" y="6192024"/>
            <a:ext cx="3412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AB5F34F-2806-DC9E-1F0E-20165D07C44A}"/>
              </a:ext>
            </a:extLst>
          </p:cNvPr>
          <p:cNvSpPr txBox="1"/>
          <p:nvPr/>
        </p:nvSpPr>
        <p:spPr>
          <a:xfrm>
            <a:off x="80428" y="1381423"/>
            <a:ext cx="2511925" cy="2246769"/>
          </a:xfrm>
          <a:prstGeom prst="rect">
            <a:avLst/>
          </a:prstGeom>
          <a:noFill/>
          <a:effectLst>
            <a:outerShdw blurRad="50800" dist="38100" dir="10800000" algn="r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esent study was done over 42 morbidly obese male cases who underwent bariatric surgery for weight reduction after doing assessments during their preoperative preparation. </a:t>
            </a:r>
          </a:p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subjects were evaluated by 4 questionnaires and serum hormone profiles pre-and postoperatively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269088-BF54-36CD-FC2F-8648D66D2ED9}"/>
              </a:ext>
            </a:extLst>
          </p:cNvPr>
          <p:cNvSpPr txBox="1"/>
          <p:nvPr/>
        </p:nvSpPr>
        <p:spPr>
          <a:xfrm>
            <a:off x="3995181" y="1199622"/>
            <a:ext cx="3161708" cy="1169551"/>
          </a:xfrm>
          <a:prstGeom prst="rect">
            <a:avLst/>
          </a:prstGeom>
          <a:noFill/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r study showed statistically significant improvement in the erectile function, and the Erection Hardness Score, among morbid obese men undergoing bariatric surgery after 6 months of operation.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467569-714E-9943-32CD-084910A5BEE3}"/>
              </a:ext>
            </a:extLst>
          </p:cNvPr>
          <p:cNvSpPr txBox="1"/>
          <p:nvPr/>
        </p:nvSpPr>
        <p:spPr>
          <a:xfrm>
            <a:off x="8150811" y="1332824"/>
            <a:ext cx="260226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bidly obese males who underwent BS showed a considerable improvement in erectile performance. </a:t>
            </a:r>
          </a:p>
        </p:txBody>
      </p:sp>
      <p:pic>
        <p:nvPicPr>
          <p:cNvPr id="17" name="Picture 16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5CC2C0A0-2333-9E16-263F-93364813D56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5" r="65809" b="44152"/>
          <a:stretch>
            <a:fillRect/>
          </a:stretch>
        </p:blipFill>
        <p:spPr>
          <a:xfrm>
            <a:off x="2345754" y="854777"/>
            <a:ext cx="1827517" cy="2170352"/>
          </a:xfrm>
          <a:prstGeom prst="rect">
            <a:avLst/>
          </a:prstGeom>
        </p:spPr>
      </p:pic>
      <p:pic>
        <p:nvPicPr>
          <p:cNvPr id="20" name="Picture 19" descr="A screen shot of a cell phone&#10;&#10;AI-generated content may be incorrect.">
            <a:extLst>
              <a:ext uri="{FF2B5EF4-FFF2-40B4-BE49-F238E27FC236}">
                <a16:creationId xmlns:a16="http://schemas.microsoft.com/office/drawing/2014/main" id="{728A821A-0BFB-6E62-8FF2-0245E3D82B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621873"/>
            <a:ext cx="3789579" cy="1743908"/>
          </a:xfrm>
          <a:prstGeom prst="rect">
            <a:avLst/>
          </a:prstGeom>
        </p:spPr>
      </p:pic>
      <p:pic>
        <p:nvPicPr>
          <p:cNvPr id="22" name="Picture 21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BFC0D9E9-E53C-6027-3B37-60A2CA496C62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70000" contrast="-7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83" t="8149" r="34967" b="51961"/>
          <a:stretch>
            <a:fillRect/>
          </a:stretch>
        </p:blipFill>
        <p:spPr>
          <a:xfrm>
            <a:off x="2697976" y="3055053"/>
            <a:ext cx="1089796" cy="1018686"/>
          </a:xfrm>
          <a:prstGeom prst="rect">
            <a:avLst/>
          </a:prstGeom>
        </p:spPr>
      </p:pic>
      <p:pic>
        <p:nvPicPr>
          <p:cNvPr id="24" name="Picture 23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50536468-39D1-C43A-2759-A2D52D435C7C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73" t="56425" r="64868" b="4771"/>
          <a:stretch>
            <a:fillRect/>
          </a:stretch>
        </p:blipFill>
        <p:spPr>
          <a:xfrm>
            <a:off x="6785813" y="2150838"/>
            <a:ext cx="1155782" cy="1069407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D9E3FD7-99C2-DE10-A34A-F8ACE6C995DB}"/>
              </a:ext>
            </a:extLst>
          </p:cNvPr>
          <p:cNvSpPr txBox="1"/>
          <p:nvPr/>
        </p:nvSpPr>
        <p:spPr>
          <a:xfrm>
            <a:off x="4145007" y="4351300"/>
            <a:ext cx="3029630" cy="1169551"/>
          </a:xfrm>
          <a:prstGeom prst="rect">
            <a:avLst/>
          </a:prstGeom>
          <a:noFill/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S is effective with a statistically significant enhancement of the Bariatric Quality of Life and Bariatric Body Image Satisfaction.</a:t>
            </a:r>
          </a:p>
          <a:p>
            <a:endParaRPr lang="en-GB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236EF90-14AE-8BE7-C34D-A39DDE44872B}"/>
              </a:ext>
            </a:extLst>
          </p:cNvPr>
          <p:cNvSpPr txBox="1"/>
          <p:nvPr/>
        </p:nvSpPr>
        <p:spPr>
          <a:xfrm>
            <a:off x="4023573" y="2776326"/>
            <a:ext cx="2667515" cy="1384995"/>
          </a:xfrm>
          <a:prstGeom prst="rect">
            <a:avLst/>
          </a:prstGeom>
          <a:noFill/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r study also showed statistically significant increasing levels of testosterone and decreasing levels of Estradiol (E2) after 6 months of operation. </a:t>
            </a:r>
          </a:p>
          <a:p>
            <a:endParaRPr lang="en-GB" sz="1400" dirty="0"/>
          </a:p>
        </p:txBody>
      </p:sp>
      <p:pic>
        <p:nvPicPr>
          <p:cNvPr id="29" name="Picture 28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13BDAFB9-3E06-644B-C697-663704A3E1A0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95" r="3674" b="47059"/>
          <a:stretch>
            <a:fillRect/>
          </a:stretch>
        </p:blipFill>
        <p:spPr>
          <a:xfrm>
            <a:off x="10726261" y="1307739"/>
            <a:ext cx="1151112" cy="1264427"/>
          </a:xfrm>
          <a:prstGeom prst="rect">
            <a:avLst/>
          </a:prstGeom>
        </p:spPr>
      </p:pic>
      <p:pic>
        <p:nvPicPr>
          <p:cNvPr id="31" name="Picture 30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FCA1A390-9DC7-B572-7D7D-D1B31CF77C72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schemeClr val="accent4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15" t="55678" r="32651" b="-1085"/>
          <a:stretch>
            <a:fillRect/>
          </a:stretch>
        </p:blipFill>
        <p:spPr>
          <a:xfrm>
            <a:off x="6983791" y="4310496"/>
            <a:ext cx="1167020" cy="1069407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9B54B8DA-C80D-0D50-FCE8-2CD7D464A412}"/>
              </a:ext>
            </a:extLst>
          </p:cNvPr>
          <p:cNvSpPr txBox="1"/>
          <p:nvPr/>
        </p:nvSpPr>
        <p:spPr>
          <a:xfrm>
            <a:off x="8158340" y="2776326"/>
            <a:ext cx="23477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enhancement was clinically demonstrated by a higher IIEF-5 score. Bariatric surgeries have a direct effect on serum sex hormones.</a:t>
            </a:r>
            <a:endParaRPr lang="en-GB"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18E85485-FE10-B4C8-40CD-F19525D89C49}"/>
              </a:ext>
            </a:extLst>
          </p:cNvPr>
          <p:cNvSpPr txBox="1"/>
          <p:nvPr/>
        </p:nvSpPr>
        <p:spPr>
          <a:xfrm>
            <a:off x="8301146" y="4295555"/>
            <a:ext cx="27616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S is effective in improving QoL and Post Bariatric Body Image Satisfaction.</a:t>
            </a:r>
            <a:endParaRPr lang="en-GB" sz="1400" dirty="0"/>
          </a:p>
        </p:txBody>
      </p:sp>
      <p:pic>
        <p:nvPicPr>
          <p:cNvPr id="100" name="Picture 99" descr="A black background with icons&#10;&#10;AI-generated content may be incorrect.">
            <a:extLst>
              <a:ext uri="{FF2B5EF4-FFF2-40B4-BE49-F238E27FC236}">
                <a16:creationId xmlns:a16="http://schemas.microsoft.com/office/drawing/2014/main" id="{45BF186D-36CA-9D36-63F6-1CD365B1AF5E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98" t="49119" r="5628" b="7842"/>
          <a:stretch>
            <a:fillRect/>
          </a:stretch>
        </p:blipFill>
        <p:spPr>
          <a:xfrm>
            <a:off x="10753080" y="3834233"/>
            <a:ext cx="1648137" cy="1672587"/>
          </a:xfrm>
          <a:prstGeom prst="rect">
            <a:avLst/>
          </a:prstGeom>
        </p:spPr>
      </p:pic>
      <p:pic>
        <p:nvPicPr>
          <p:cNvPr id="102" name="Picture 101" descr="A black background with a black border&#10;&#10;AI-generated content may be incorrect.">
            <a:extLst>
              <a:ext uri="{FF2B5EF4-FFF2-40B4-BE49-F238E27FC236}">
                <a16:creationId xmlns:a16="http://schemas.microsoft.com/office/drawing/2014/main" id="{D01D678E-28F2-E089-1064-88914C696950}"/>
              </a:ext>
            </a:extLst>
          </p:cNvPr>
          <p:cNvPicPr>
            <a:picLocks noChangeAspect="1"/>
          </p:cNvPicPr>
          <p:nvPr/>
        </p:nvPicPr>
        <p:blipFill>
          <a:blip r:embed="rId7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46" t="57538" r="7754" b="15974"/>
          <a:stretch>
            <a:fillRect/>
          </a:stretch>
        </p:blipFill>
        <p:spPr>
          <a:xfrm>
            <a:off x="10522456" y="2757707"/>
            <a:ext cx="1456739" cy="1020822"/>
          </a:xfrm>
          <a:prstGeom prst="rect">
            <a:avLst/>
          </a:prstGeom>
          <a:ln>
            <a:solidFill>
              <a:srgbClr val="0110D1"/>
            </a:solidFill>
          </a:ln>
        </p:spPr>
      </p:pic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17</TotalTime>
  <Words>208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Doctor-8</cp:lastModifiedBy>
  <cp:revision>95</cp:revision>
  <dcterms:created xsi:type="dcterms:W3CDTF">2017-10-03T08:27:08Z</dcterms:created>
  <dcterms:modified xsi:type="dcterms:W3CDTF">2025-09-14T08:11:37Z</dcterms:modified>
</cp:coreProperties>
</file>